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427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 showGuides="1">
      <p:cViewPr varScale="1">
        <p:scale>
          <a:sx n="86" d="100"/>
          <a:sy n="86" d="100"/>
        </p:scale>
        <p:origin x="246" y="90"/>
      </p:cViewPr>
      <p:guideLst>
        <p:guide orient="horz" pos="2160"/>
        <p:guide pos="427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C1945F7-B467-48B4-A7E6-0858C020E14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727510A3-49DA-4EE1-8A10-4625DE7A342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1C19AAC-DE4D-469A-A218-9797A535BA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2BADD-4439-49DF-9AF8-334118CACDA4}" type="datetimeFigureOut">
              <a:rPr lang="zh-CN" altLang="en-US" smtClean="0"/>
              <a:t>2020-04-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F105539-05AD-461B-B6F1-29AB5082D9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06F059F-D28A-42F1-BD87-8586977FAC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A167BA-FAB8-45AD-9DBB-1D489F1E1F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44375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C61B60E-FACD-47EC-8994-417C64CC77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D6CC289-114E-48C4-BB9C-907E72F925D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DFD535A-6781-4B83-900B-60E4A5DE42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2BADD-4439-49DF-9AF8-334118CACDA4}" type="datetimeFigureOut">
              <a:rPr lang="zh-CN" altLang="en-US" smtClean="0"/>
              <a:t>2020-04-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C069829-FA13-47A1-8EF1-8086F6A203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25AB2D6-9F77-4726-BC98-2557967820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A167BA-FAB8-45AD-9DBB-1D489F1E1F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98936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5095F87F-2403-40D8-B758-E2302D8C04C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E9A64D3-12D6-4512-B086-27BCACA78A5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244EA97-8DEE-4718-952B-E553DD1876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2BADD-4439-49DF-9AF8-334118CACDA4}" type="datetimeFigureOut">
              <a:rPr lang="zh-CN" altLang="en-US" smtClean="0"/>
              <a:t>2020-04-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A8480A0-D6E1-4E77-AD58-255A277529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0CB5149-B63C-4D40-84A2-8251D3C494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A167BA-FAB8-45AD-9DBB-1D489F1E1F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218628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3468B8F-5CEF-47E9-BEDC-FA8544A412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8A1A820-85A6-4E25-8A9D-FDEED6BDAC2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58975E7-AD80-4D6E-8936-170F83A50B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2BADD-4439-49DF-9AF8-334118CACDA4}" type="datetimeFigureOut">
              <a:rPr lang="zh-CN" altLang="en-US" smtClean="0"/>
              <a:t>2020-04-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5D0F8BC-55BA-4687-B92F-C1ACEB7C33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8D26154-9153-4163-9EA6-EE68CB7FF0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A167BA-FAB8-45AD-9DBB-1D489F1E1F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24463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4149792-E844-44E0-96ED-2E5DF4362C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B2C7FC0-6C1A-4479-9B44-51D25FA54C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A117297-FADB-409E-BE9D-2E59B28946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2BADD-4439-49DF-9AF8-334118CACDA4}" type="datetimeFigureOut">
              <a:rPr lang="zh-CN" altLang="en-US" smtClean="0"/>
              <a:t>2020-04-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69C32C6-0CEA-44DF-9042-227B42B8EA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2FBFF4C-B2A6-4F0A-94BE-F2704722ED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A167BA-FAB8-45AD-9DBB-1D489F1E1F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0454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3B685D6-4ECE-4739-A4EB-B8E4E41312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C581A2C-99BD-4F55-8EC5-E6620BF4EF8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B767CC2-488C-4525-974E-358E47D07C3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1CCF68E-B096-48A4-9DEE-15B3197245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2BADD-4439-49DF-9AF8-334118CACDA4}" type="datetimeFigureOut">
              <a:rPr lang="zh-CN" altLang="en-US" smtClean="0"/>
              <a:t>2020-04-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8E75240-67FF-4AD8-A2C4-9146ABF8A1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F0BB8B7-491F-4266-8FDE-B6274A6224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A167BA-FAB8-45AD-9DBB-1D489F1E1F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58543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9877556-2A8B-4E52-A537-227AE230BA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D057B9E-76C3-4FAC-9BA0-C15DF2783D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703ACD1-A399-4C3C-BB17-9A374CBF955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C154D4D0-F846-409B-AAD5-972AD764F33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0BC00A5A-1BB6-4D38-B201-B32B8D2D54D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78248A76-EEF7-4DDF-B65C-E4FED27B0C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2BADD-4439-49DF-9AF8-334118CACDA4}" type="datetimeFigureOut">
              <a:rPr lang="zh-CN" altLang="en-US" smtClean="0"/>
              <a:t>2020-04-2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C19FBAA5-1EE3-41DA-BA34-CC87E6F15F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6F11E674-C30F-48B6-A4EA-3317ED4D82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A167BA-FAB8-45AD-9DBB-1D489F1E1F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874972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CAD6BC9-FC7C-4B36-9768-59800D1488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64D82459-546F-40A2-A177-44A22344C3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2BADD-4439-49DF-9AF8-334118CACDA4}" type="datetimeFigureOut">
              <a:rPr lang="zh-CN" altLang="en-US" smtClean="0"/>
              <a:t>2020-04-2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1442F243-7DA9-4449-88BC-FE046BBAAF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93B11FE4-09CD-47C7-AC54-5A2C1D6754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A167BA-FAB8-45AD-9DBB-1D489F1E1F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749710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90A49818-62B5-4027-9281-6D00C63974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2BADD-4439-49DF-9AF8-334118CACDA4}" type="datetimeFigureOut">
              <a:rPr lang="zh-CN" altLang="en-US" smtClean="0"/>
              <a:t>2020-04-2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34AA9843-4A88-4DD6-96B3-8E60DE615E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1A7A6ACE-33AA-4BAD-A860-F590C25FA2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A167BA-FAB8-45AD-9DBB-1D489F1E1F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01035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63063C1-C5F1-47E1-951E-811A083E7C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EDE93FA-4913-4AC1-B524-99B1BBBB06B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43798E21-4298-43DE-AF7A-02E91BA9557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29BB098-602C-46FB-AA43-D691AD8842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2BADD-4439-49DF-9AF8-334118CACDA4}" type="datetimeFigureOut">
              <a:rPr lang="zh-CN" altLang="en-US" smtClean="0"/>
              <a:t>2020-04-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470C918-81FF-4519-B0FC-A779A8EEE2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3C9A605-8282-4677-9364-50506ACA84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A167BA-FAB8-45AD-9DBB-1D489F1E1F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314195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781A13A-18CA-492D-886A-3E7623A5B5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74B1A2A8-0526-4794-A563-2CDCEBD26F0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5EF8A0A-A041-44CF-A400-A765E92D30B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C6ECF53-684A-419D-8439-A4859A4F1B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2BADD-4439-49DF-9AF8-334118CACDA4}" type="datetimeFigureOut">
              <a:rPr lang="zh-CN" altLang="en-US" smtClean="0"/>
              <a:t>2020-04-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253E8F6-EAFE-4183-8EC5-73A58F1E82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4BD368D-DCE5-4EC5-9CB0-F0EA82A134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A167BA-FAB8-45AD-9DBB-1D489F1E1F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07292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42E8B373-20B8-4F93-AF59-FC2053D6E3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C9B2634-4AE0-4C70-926B-F092D795BA3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ACE8344-55B2-40FA-BB98-FDBDC61CBC8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92BADD-4439-49DF-9AF8-334118CACDA4}" type="datetimeFigureOut">
              <a:rPr lang="zh-CN" altLang="en-US" smtClean="0"/>
              <a:t>2020-04-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2699EEF-59C2-4C16-B4AD-876E8C0A16C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852BBE2-9D62-4097-BCCC-4D9B23B5E59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A167BA-FAB8-45AD-9DBB-1D489F1E1F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6779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1356F522-CC33-4F06-84E3-3724F0F721C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3888"/>
          <a:stretch/>
        </p:blipFill>
        <p:spPr>
          <a:xfrm>
            <a:off x="2085061" y="269838"/>
            <a:ext cx="8021877" cy="4803967"/>
          </a:xfrm>
          <a:prstGeom prst="rect">
            <a:avLst/>
          </a:prstGeom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id="{3E1646B8-0D19-4FFC-BCC0-4BCE448DA627}"/>
              </a:ext>
            </a:extLst>
          </p:cNvPr>
          <p:cNvSpPr/>
          <p:nvPr/>
        </p:nvSpPr>
        <p:spPr>
          <a:xfrm>
            <a:off x="2579647" y="5263815"/>
            <a:ext cx="6831981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kern="100" dirty="0">
                <a:latin typeface="Times New Roman" panose="02020603050405020304" pitchFamily="18" charset="0"/>
                <a:ea typeface="宋体" panose="02010600030101010101" pitchFamily="2" charset="-122"/>
              </a:rPr>
              <a:t>Fig. S2 Expression levels of core genes and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r>
              <a:rPr lang="en-US" altLang="zh-CN" sz="1600" b="1" kern="100" dirty="0">
                <a:latin typeface="Times New Roman" panose="02020603050405020304" pitchFamily="18" charset="0"/>
                <a:ea typeface="宋体" panose="02010600030101010101" pitchFamily="2" charset="-122"/>
              </a:rPr>
              <a:t>transcription factors involved in anthocyanin biosynthesis in mulberry fruit measured by qPCR.</a:t>
            </a:r>
            <a:endParaRPr lang="zh-CN" altLang="en-US" sz="1600" dirty="0"/>
          </a:p>
        </p:txBody>
      </p:sp>
    </p:spTree>
    <p:extLst>
      <p:ext uri="{BB962C8B-B14F-4D97-AF65-F5344CB8AC3E}">
        <p14:creationId xmlns:p14="http://schemas.microsoft.com/office/powerpoint/2010/main" val="27231486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54</TotalTime>
  <Words>22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宋体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ecurity Mail</dc:creator>
  <cp:lastModifiedBy>Security Mail</cp:lastModifiedBy>
  <cp:revision>10</cp:revision>
  <dcterms:created xsi:type="dcterms:W3CDTF">2019-12-13T09:03:11Z</dcterms:created>
  <dcterms:modified xsi:type="dcterms:W3CDTF">2020-04-22T01:20:42Z</dcterms:modified>
</cp:coreProperties>
</file>